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7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66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-774"/>
      </p:cViewPr>
      <p:guideLst>
        <p:guide orient="horz" pos="312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0A6D4-D143-4FB8-816C-80B00EEAEC99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7ACFC-25D4-4034-8394-1192ACC981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2840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46726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9019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42638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634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9562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18742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179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5743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8707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2930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64082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28250-0A57-4107-8DBB-AF22CFB01145}" type="datetimeFigureOut">
              <a:rPr lang="en-AU" smtClean="0"/>
              <a:t>23/05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CC6F5-E90B-489A-A9AC-327E5CAF99F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0342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7727791"/>
              </p:ext>
            </p:extLst>
          </p:nvPr>
        </p:nvGraphicFramePr>
        <p:xfrm>
          <a:off x="549945" y="3141662"/>
          <a:ext cx="5598505" cy="243770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82908">
                  <a:extLst>
                    <a:ext uri="{9D8B030D-6E8A-4147-A177-3AD203B41FA5}">
                      <a16:colId xmlns:a16="http://schemas.microsoft.com/office/drawing/2014/main" val="1608380588"/>
                    </a:ext>
                  </a:extLst>
                </a:gridCol>
                <a:gridCol w="1066289">
                  <a:extLst>
                    <a:ext uri="{9D8B030D-6E8A-4147-A177-3AD203B41FA5}">
                      <a16:colId xmlns:a16="http://schemas.microsoft.com/office/drawing/2014/main" val="1094018463"/>
                    </a:ext>
                  </a:extLst>
                </a:gridCol>
                <a:gridCol w="1092994">
                  <a:extLst>
                    <a:ext uri="{9D8B030D-6E8A-4147-A177-3AD203B41FA5}">
                      <a16:colId xmlns:a16="http://schemas.microsoft.com/office/drawing/2014/main" val="2408862806"/>
                    </a:ext>
                  </a:extLst>
                </a:gridCol>
                <a:gridCol w="1088048">
                  <a:extLst>
                    <a:ext uri="{9D8B030D-6E8A-4147-A177-3AD203B41FA5}">
                      <a16:colId xmlns:a16="http://schemas.microsoft.com/office/drawing/2014/main" val="1838737300"/>
                    </a:ext>
                  </a:extLst>
                </a:gridCol>
                <a:gridCol w="1068266">
                  <a:extLst>
                    <a:ext uri="{9D8B030D-6E8A-4147-A177-3AD203B41FA5}">
                      <a16:colId xmlns:a16="http://schemas.microsoft.com/office/drawing/2014/main" val="441111634"/>
                    </a:ext>
                  </a:extLst>
                </a:gridCol>
              </a:tblGrid>
              <a:tr h="52497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ore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 infiltration</a:t>
                      </a:r>
                      <a:endParaRPr lang="en-AU" sz="7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filtration of 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-3 cells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filtration of</a:t>
                      </a:r>
                      <a:r>
                        <a:rPr lang="en-AU" sz="7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 cells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filtration of &gt;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 cells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extLst>
                  <a:ext uri="{0D108BD9-81ED-4DB2-BD59-A6C34878D82A}">
                    <a16:rowId xmlns:a16="http://schemas.microsoft.com/office/drawing/2014/main" val="1014210800"/>
                  </a:ext>
                </a:extLst>
              </a:tr>
              <a:tr h="95129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yocardium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ˣ200)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endParaRPr lang="en-AU" sz="80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 dirty="0"/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152048428"/>
                  </a:ext>
                </a:extLst>
              </a:tr>
              <a:tr h="96143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tral valve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b="1" spc="25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ˣ200)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/>
                </a:tc>
                <a:tc>
                  <a:txBody>
                    <a:bodyPr/>
                    <a:lstStyle/>
                    <a:p>
                      <a:endParaRPr lang="en-AU" sz="800" dirty="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/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endParaRPr lang="en-AU" sz="800" dirty="0"/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516592170"/>
                  </a:ext>
                </a:extLst>
              </a:tr>
            </a:tbl>
          </a:graphicData>
        </a:graphic>
      </p:graphicFrame>
      <p:sp>
        <p:nvSpPr>
          <p:cNvPr id="40" name="Rectangle 39"/>
          <p:cNvSpPr/>
          <p:nvPr/>
        </p:nvSpPr>
        <p:spPr>
          <a:xfrm>
            <a:off x="20409" y="5677312"/>
            <a:ext cx="68580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. Scoring matrix for immune cell infiltration </a:t>
            </a:r>
          </a:p>
          <a:p>
            <a:pPr algn="just"/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Formalin fixed paraffin embedded sections were stained with CD3+ T-cell, CD68+ macrophages,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FN-γ+ and IL-17A+ T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using standard protocols. Stained tissue were scanned by Hamamatsu </a:t>
            </a:r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NanoZoomer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 2.0 slide scanner and examined using NDP.view2 Plus image viewer. Quantification of infiltrating cells in both myocardium and valvular tissues was performed manually using 5 different sections of the myocardium and the valvular tissue from each rat. Individual scores (0-3) for both myocardial and valvular tissue were summed to derive at the total number of infiltrating cells per section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5E46B25-72BD-421A-8112-65D8FF8A3945}"/>
              </a:ext>
            </a:extLst>
          </p:cNvPr>
          <p:cNvGrpSpPr/>
          <p:nvPr/>
        </p:nvGrpSpPr>
        <p:grpSpPr>
          <a:xfrm>
            <a:off x="1860551" y="3684811"/>
            <a:ext cx="4287899" cy="1865381"/>
            <a:chOff x="1860551" y="3684811"/>
            <a:chExt cx="4287899" cy="1865381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41372" y="4643048"/>
              <a:ext cx="1002059" cy="90714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41592" y="3689756"/>
              <a:ext cx="1001621" cy="9038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60551" y="3684811"/>
              <a:ext cx="1001621" cy="90383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48599" y="3689756"/>
              <a:ext cx="1001621" cy="9038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114803" y="3694704"/>
              <a:ext cx="1001621" cy="90383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119749" y="4643048"/>
              <a:ext cx="1001621" cy="906926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60551" y="4647996"/>
              <a:ext cx="1001621" cy="901978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48599" y="4647996"/>
              <a:ext cx="1001621" cy="90197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15" name="Straight Arrow Connector 14"/>
            <p:cNvCxnSpPr/>
            <p:nvPr/>
          </p:nvCxnSpPr>
          <p:spPr>
            <a:xfrm flipH="1">
              <a:off x="3524512" y="3901624"/>
              <a:ext cx="56365" cy="12284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 flipH="1" flipV="1">
              <a:off x="3259660" y="4414072"/>
              <a:ext cx="42340" cy="12762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4089400" y="3930429"/>
              <a:ext cx="30701" cy="14106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 flipH="1">
              <a:off x="4907628" y="3995666"/>
              <a:ext cx="32672" cy="14106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flipH="1" flipV="1">
              <a:off x="4744495" y="4267572"/>
              <a:ext cx="49057" cy="1346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flipH="1" flipV="1">
              <a:off x="4486514" y="4146622"/>
              <a:ext cx="28336" cy="16284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5180985" y="3841750"/>
              <a:ext cx="40104" cy="15391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 flipH="1">
              <a:off x="5962554" y="4267572"/>
              <a:ext cx="28787" cy="13593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H="1" flipV="1">
              <a:off x="5863391" y="4457902"/>
              <a:ext cx="4162" cy="13074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flipH="1" flipV="1">
              <a:off x="5650835" y="4318431"/>
              <a:ext cx="23804" cy="13947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 flipH="1">
              <a:off x="5854438" y="3901624"/>
              <a:ext cx="19835" cy="14106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 flipH="1" flipV="1">
              <a:off x="5991341" y="4503525"/>
              <a:ext cx="157109" cy="3816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>
              <a:off x="5180985" y="5001958"/>
              <a:ext cx="40104" cy="13803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5964150" y="4897547"/>
              <a:ext cx="27191" cy="15143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 flipV="1">
              <a:off x="5867554" y="5096511"/>
              <a:ext cx="22223" cy="13256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5615613" y="4829592"/>
              <a:ext cx="59027" cy="13591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H="1">
              <a:off x="6070031" y="4696483"/>
              <a:ext cx="46393" cy="1331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flipV="1">
              <a:off x="5467350" y="5276282"/>
              <a:ext cx="3188" cy="1215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H="1">
              <a:off x="4168381" y="4932972"/>
              <a:ext cx="46920" cy="13797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 flipH="1">
              <a:off x="4369814" y="4815595"/>
              <a:ext cx="28788" cy="11772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 flipH="1">
              <a:off x="3184950" y="5012374"/>
              <a:ext cx="74710" cy="1491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>
              <a:off x="3580877" y="5048979"/>
              <a:ext cx="51323" cy="10925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/>
            <p:cNvCxnSpPr/>
            <p:nvPr/>
          </p:nvCxnSpPr>
          <p:spPr>
            <a:xfrm flipH="1">
              <a:off x="3684139" y="5035329"/>
              <a:ext cx="51323" cy="10925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/>
            <p:cNvCxnSpPr/>
            <p:nvPr/>
          </p:nvCxnSpPr>
          <p:spPr>
            <a:xfrm flipH="1">
              <a:off x="4542401" y="4697867"/>
              <a:ext cx="28788" cy="11772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 flipH="1">
              <a:off x="4767262" y="4661908"/>
              <a:ext cx="28788" cy="11772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42994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5</TotalTime>
  <Words>138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kshan Mohamed Raseek</dc:creator>
  <cp:lastModifiedBy>Rukshan Mohamed Raseek</cp:lastModifiedBy>
  <cp:revision>118</cp:revision>
  <cp:lastPrinted>2023-12-01T00:56:27Z</cp:lastPrinted>
  <dcterms:created xsi:type="dcterms:W3CDTF">2023-11-20T22:53:03Z</dcterms:created>
  <dcterms:modified xsi:type="dcterms:W3CDTF">2025-05-23T00:39:14Z</dcterms:modified>
</cp:coreProperties>
</file>